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 varScale="1">
        <p:scale>
          <a:sx n="55" d="100"/>
          <a:sy n="55" d="100"/>
        </p:scale>
        <p:origin x="2501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3430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2568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0677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924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1336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4432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7514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8208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2430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9028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8516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3132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o 12">
            <a:extLst>
              <a:ext uri="{FF2B5EF4-FFF2-40B4-BE49-F238E27FC236}">
                <a16:creationId xmlns:a16="http://schemas.microsoft.com/office/drawing/2014/main" id="{03DCA6E8-376C-4C10-A632-9894716E7973}"/>
              </a:ext>
            </a:extLst>
          </p:cNvPr>
          <p:cNvGrpSpPr/>
          <p:nvPr/>
        </p:nvGrpSpPr>
        <p:grpSpPr>
          <a:xfrm>
            <a:off x="203200" y="2293866"/>
            <a:ext cx="6454672" cy="5318267"/>
            <a:chOff x="274892" y="1311668"/>
            <a:chExt cx="6454672" cy="5318267"/>
          </a:xfrm>
        </p:grpSpPr>
        <p:graphicFrame>
          <p:nvGraphicFramePr>
            <p:cNvPr id="2" name="Objeto 1">
              <a:extLst>
                <a:ext uri="{FF2B5EF4-FFF2-40B4-BE49-F238E27FC236}">
                  <a16:creationId xmlns:a16="http://schemas.microsoft.com/office/drawing/2014/main" id="{E04030FF-DB1A-44F2-909F-C0B2A8391AA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42650365"/>
                </p:ext>
              </p:extLst>
            </p:nvPr>
          </p:nvGraphicFramePr>
          <p:xfrm>
            <a:off x="282830" y="1562565"/>
            <a:ext cx="3221037" cy="23034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776383" imgH="2700075" progId="Prism10.Document">
                    <p:embed/>
                  </p:oleObj>
                </mc:Choice>
                <mc:Fallback>
                  <p:oleObj name="Prism 10" r:id="rId2" imgW="3776383" imgH="2700075" progId="Prism10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id="{E04030FF-DB1A-44F2-909F-C0B2A8391AA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82830" y="1562565"/>
                          <a:ext cx="3221037" cy="23034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1DA453AA-1713-457F-8C14-EDD03482E6BD}"/>
                </a:ext>
              </a:extLst>
            </p:cNvPr>
            <p:cNvSpPr txBox="1"/>
            <p:nvPr/>
          </p:nvSpPr>
          <p:spPr>
            <a:xfrm>
              <a:off x="638887" y="1311668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ld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OVID-19 (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covered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4876; 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0401</a:t>
              </a:r>
            </a:p>
          </p:txBody>
        </p:sp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088BD21A-0001-4496-BB7E-63A79A8CE6C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99163584"/>
                </p:ext>
              </p:extLst>
            </p:nvPr>
          </p:nvGraphicFramePr>
          <p:xfrm>
            <a:off x="3465767" y="1610190"/>
            <a:ext cx="3182938" cy="22653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794750" imgH="2700075" progId="Prism10.Document">
                    <p:embed/>
                  </p:oleObj>
                </mc:Choice>
                <mc:Fallback>
                  <p:oleObj name="Prism 10" r:id="rId4" imgW="3794750" imgH="2700075" progId="Prism10.Document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088BD21A-0001-4496-BB7E-63A79A8CE6C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465767" y="1610190"/>
                          <a:ext cx="3182938" cy="22653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to 5">
              <a:extLst>
                <a:ext uri="{FF2B5EF4-FFF2-40B4-BE49-F238E27FC236}">
                  <a16:creationId xmlns:a16="http://schemas.microsoft.com/office/drawing/2014/main" id="{5B58DCBB-CE58-49C3-B8C8-0A8BA21BAB1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83773959"/>
                </p:ext>
              </p:extLst>
            </p:nvPr>
          </p:nvGraphicFramePr>
          <p:xfrm>
            <a:off x="274892" y="4289890"/>
            <a:ext cx="3287713" cy="2339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3794750" imgH="2700075" progId="Prism10.Document">
                    <p:embed/>
                  </p:oleObj>
                </mc:Choice>
                <mc:Fallback>
                  <p:oleObj name="Prism 10" r:id="rId6" imgW="3794750" imgH="2700075" progId="Prism10.Document">
                    <p:embed/>
                    <p:pic>
                      <p:nvPicPr>
                        <p:cNvPr id="6" name="Objeto 5">
                          <a:extLst>
                            <a:ext uri="{FF2B5EF4-FFF2-40B4-BE49-F238E27FC236}">
                              <a16:creationId xmlns:a16="http://schemas.microsoft.com/office/drawing/2014/main" id="{5B58DCBB-CE58-49C3-B8C8-0A8BA21BAB1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74892" y="4289890"/>
                          <a:ext cx="3287713" cy="2339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to 7">
              <a:extLst>
                <a:ext uri="{FF2B5EF4-FFF2-40B4-BE49-F238E27FC236}">
                  <a16:creationId xmlns:a16="http://schemas.microsoft.com/office/drawing/2014/main" id="{CC387AD8-3011-48AB-8BCD-1362683095E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18970214"/>
                </p:ext>
              </p:extLst>
            </p:nvPr>
          </p:nvGraphicFramePr>
          <p:xfrm>
            <a:off x="3460901" y="4304247"/>
            <a:ext cx="3268663" cy="23256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3794750" imgH="2700075" progId="Prism10.Document">
                    <p:embed/>
                  </p:oleObj>
                </mc:Choice>
                <mc:Fallback>
                  <p:oleObj name="Prism 10" r:id="rId8" imgW="3794750" imgH="2700075" progId="Prism10.Document">
                    <p:embed/>
                    <p:pic>
                      <p:nvPicPr>
                        <p:cNvPr id="8" name="Objeto 7">
                          <a:extLst>
                            <a:ext uri="{FF2B5EF4-FFF2-40B4-BE49-F238E27FC236}">
                              <a16:creationId xmlns:a16="http://schemas.microsoft.com/office/drawing/2014/main" id="{CC387AD8-3011-48AB-8BCD-1362683095E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460901" y="4304247"/>
                          <a:ext cx="3268663" cy="23256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BB012CCE-C7F6-42D5-B55D-2C2A437A9B09}"/>
                </a:ext>
              </a:extLst>
            </p:cNvPr>
            <p:cNvSpPr txBox="1"/>
            <p:nvPr/>
          </p:nvSpPr>
          <p:spPr>
            <a:xfrm>
              <a:off x="3800099" y="1311668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vere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OVID-19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0.1333 ; p=0. 5864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CC7964F2-44FA-445E-B37B-E87DD644AE9C}"/>
                </a:ext>
              </a:extLst>
            </p:cNvPr>
            <p:cNvSpPr txBox="1"/>
            <p:nvPr/>
          </p:nvSpPr>
          <p:spPr>
            <a:xfrm>
              <a:off x="638887" y="4020034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ritical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OVID-19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0.0159; p=0.9483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708C28DB-5DC9-4DAC-A7E9-DEEC504B5A65}"/>
                </a:ext>
              </a:extLst>
            </p:cNvPr>
            <p:cNvSpPr txBox="1"/>
            <p:nvPr/>
          </p:nvSpPr>
          <p:spPr>
            <a:xfrm>
              <a:off x="3800099" y="4020034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CC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5375 ; 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0261</a:t>
              </a:r>
            </a:p>
          </p:txBody>
        </p:sp>
      </p:grpSp>
      <p:sp>
        <p:nvSpPr>
          <p:cNvPr id="14" name="CuadroTexto 13">
            <a:extLst>
              <a:ext uri="{FF2B5EF4-FFF2-40B4-BE49-F238E27FC236}">
                <a16:creationId xmlns:a16="http://schemas.microsoft.com/office/drawing/2014/main" id="{543E349A-8E87-4F36-AE53-494FC4AB45C8}"/>
              </a:ext>
            </a:extLst>
          </p:cNvPr>
          <p:cNvSpPr txBox="1"/>
          <p:nvPr/>
        </p:nvSpPr>
        <p:spPr>
          <a:xfrm>
            <a:off x="405340" y="379725"/>
            <a:ext cx="59659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4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arson's correlation between the levels of CD4+ Th2 and the expression of IL-4 in these cells in the different cohorts. Pearson's coefficient r and p-values were calculated with GraphPad Software Inc. (San Diego, CA).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8752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6</TotalTime>
  <Words>86</Words>
  <Application>Microsoft Office PowerPoint</Application>
  <PresentationFormat>A4 (210 x 297 mm)</PresentationFormat>
  <Paragraphs>9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ism 10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ánchez Menéndez</dc:creator>
  <cp:lastModifiedBy>Mayte Coiras</cp:lastModifiedBy>
  <cp:revision>50</cp:revision>
  <cp:lastPrinted>2024-02-23T14:10:25Z</cp:lastPrinted>
  <dcterms:created xsi:type="dcterms:W3CDTF">2024-02-22T09:28:26Z</dcterms:created>
  <dcterms:modified xsi:type="dcterms:W3CDTF">2024-05-11T09:01:41Z</dcterms:modified>
</cp:coreProperties>
</file>